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99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Documents%20and%20Settings\Butterfield\grants\AFPprimeboostRO1\Immune%20Monitoring\NC%20comparison%2010.16.2012.xls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5.3697205496371803E-2"/>
          <c:y val="2.9313570283707999E-2"/>
          <c:w val="0.92389180176007746"/>
          <c:h val="0.649225034801155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raph!$C$3</c:f>
              <c:strCache>
                <c:ptCount val="1"/>
                <c:pt idx="0">
                  <c:v>HD1</c:v>
                </c:pt>
              </c:strCache>
            </c:strRef>
          </c:tx>
          <c:invertIfNegative val="0"/>
          <c:cat>
            <c:strRef>
              <c:f>graph!$B$4:$B$23</c:f>
              <c:strCache>
                <c:ptCount val="20"/>
                <c:pt idx="0">
                  <c:v>CD8 + alone</c:v>
                </c:pt>
                <c:pt idx="1">
                  <c:v>CD8 + PMA/ION</c:v>
                </c:pt>
                <c:pt idx="2">
                  <c:v>CD8 + autologous DC</c:v>
                </c:pt>
                <c:pt idx="3">
                  <c:v>CD8 + auto DC+ AFP</c:v>
                </c:pt>
                <c:pt idx="4">
                  <c:v>CD8+auto DC + AdVLacZ</c:v>
                </c:pt>
                <c:pt idx="5">
                  <c:v>CD8+T2</c:v>
                </c:pt>
                <c:pt idx="6">
                  <c:v>CD8 + T2 + AFP 158</c:v>
                </c:pt>
                <c:pt idx="7">
                  <c:v>CD8 + T2 + AFP 542</c:v>
                </c:pt>
                <c:pt idx="8">
                  <c:v>CD8 + T2 + AdV hexon 711-721</c:v>
                </c:pt>
                <c:pt idx="9">
                  <c:v>CD8 + T2 + AFP 137</c:v>
                </c:pt>
                <c:pt idx="10">
                  <c:v>CD8 + T2 + AFP 325</c:v>
                </c:pt>
                <c:pt idx="12">
                  <c:v>CD4 + alone</c:v>
                </c:pt>
                <c:pt idx="13">
                  <c:v>CD4 + PMA/ION</c:v>
                </c:pt>
                <c:pt idx="14">
                  <c:v>CD4 + autologous DC</c:v>
                </c:pt>
                <c:pt idx="15">
                  <c:v>CD4 + autologous DC+AFP</c:v>
                </c:pt>
                <c:pt idx="16">
                  <c:v>CD4 + auto DC + AdVLacZ</c:v>
                </c:pt>
                <c:pt idx="17">
                  <c:v>CD4 + auto DC + AdV hexon 901-930</c:v>
                </c:pt>
                <c:pt idx="18">
                  <c:v>CD4 + auto DC + AdV hexon 856-885</c:v>
                </c:pt>
                <c:pt idx="19">
                  <c:v>CD4 + auto DC + AdV hexon 571-600</c:v>
                </c:pt>
              </c:strCache>
            </c:strRef>
          </c:cat>
          <c:val>
            <c:numRef>
              <c:f>graph!$C$4:$C$23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6</c:v>
                </c:pt>
                <c:pt idx="4">
                  <c:v>130</c:v>
                </c:pt>
                <c:pt idx="5">
                  <c:v>41</c:v>
                </c:pt>
                <c:pt idx="6">
                  <c:v>31</c:v>
                </c:pt>
                <c:pt idx="7">
                  <c:v>33</c:v>
                </c:pt>
                <c:pt idx="8">
                  <c:v>40</c:v>
                </c:pt>
                <c:pt idx="9">
                  <c:v>0</c:v>
                </c:pt>
                <c:pt idx="10">
                  <c:v>0</c:v>
                </c:pt>
                <c:pt idx="12">
                  <c:v>0</c:v>
                </c:pt>
                <c:pt idx="13">
                  <c:v>1000</c:v>
                </c:pt>
                <c:pt idx="14">
                  <c:v>10</c:v>
                </c:pt>
                <c:pt idx="15">
                  <c:v>10</c:v>
                </c:pt>
                <c:pt idx="16">
                  <c:v>47</c:v>
                </c:pt>
                <c:pt idx="17">
                  <c:v>9</c:v>
                </c:pt>
                <c:pt idx="18">
                  <c:v>4</c:v>
                </c:pt>
                <c:pt idx="19">
                  <c:v>3</c:v>
                </c:pt>
              </c:numCache>
            </c:numRef>
          </c:val>
        </c:ser>
        <c:ser>
          <c:idx val="1"/>
          <c:order val="1"/>
          <c:tx>
            <c:strRef>
              <c:f>graph!$D$3</c:f>
              <c:strCache>
                <c:ptCount val="1"/>
                <c:pt idx="0">
                  <c:v>HD2</c:v>
                </c:pt>
              </c:strCache>
            </c:strRef>
          </c:tx>
          <c:invertIfNegative val="0"/>
          <c:cat>
            <c:strRef>
              <c:f>graph!$B$4:$B$23</c:f>
              <c:strCache>
                <c:ptCount val="20"/>
                <c:pt idx="0">
                  <c:v>CD8 + alone</c:v>
                </c:pt>
                <c:pt idx="1">
                  <c:v>CD8 + PMA/ION</c:v>
                </c:pt>
                <c:pt idx="2">
                  <c:v>CD8 + autologous DC</c:v>
                </c:pt>
                <c:pt idx="3">
                  <c:v>CD8 + auto DC+ AFP</c:v>
                </c:pt>
                <c:pt idx="4">
                  <c:v>CD8+auto DC + AdVLacZ</c:v>
                </c:pt>
                <c:pt idx="5">
                  <c:v>CD8+T2</c:v>
                </c:pt>
                <c:pt idx="6">
                  <c:v>CD8 + T2 + AFP 158</c:v>
                </c:pt>
                <c:pt idx="7">
                  <c:v>CD8 + T2 + AFP 542</c:v>
                </c:pt>
                <c:pt idx="8">
                  <c:v>CD8 + T2 + AdV hexon 711-721</c:v>
                </c:pt>
                <c:pt idx="9">
                  <c:v>CD8 + T2 + AFP 137</c:v>
                </c:pt>
                <c:pt idx="10">
                  <c:v>CD8 + T2 + AFP 325</c:v>
                </c:pt>
                <c:pt idx="12">
                  <c:v>CD4 + alone</c:v>
                </c:pt>
                <c:pt idx="13">
                  <c:v>CD4 + PMA/ION</c:v>
                </c:pt>
                <c:pt idx="14">
                  <c:v>CD4 + autologous DC</c:v>
                </c:pt>
                <c:pt idx="15">
                  <c:v>CD4 + autologous DC+AFP</c:v>
                </c:pt>
                <c:pt idx="16">
                  <c:v>CD4 + auto DC + AdVLacZ</c:v>
                </c:pt>
                <c:pt idx="17">
                  <c:v>CD4 + auto DC + AdV hexon 901-930</c:v>
                </c:pt>
                <c:pt idx="18">
                  <c:v>CD4 + auto DC + AdV hexon 856-885</c:v>
                </c:pt>
                <c:pt idx="19">
                  <c:v>CD4 + auto DC + AdV hexon 571-600</c:v>
                </c:pt>
              </c:strCache>
            </c:strRef>
          </c:cat>
          <c:val>
            <c:numRef>
              <c:f>graph!$D$4:$D$23</c:f>
              <c:numCache>
                <c:formatCode>General</c:formatCode>
                <c:ptCount val="20"/>
                <c:pt idx="0">
                  <c:v>0</c:v>
                </c:pt>
                <c:pt idx="1">
                  <c:v>100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2">
                  <c:v>0</c:v>
                </c:pt>
                <c:pt idx="13">
                  <c:v>1000</c:v>
                </c:pt>
                <c:pt idx="14">
                  <c:v>1</c:v>
                </c:pt>
                <c:pt idx="15">
                  <c:v>2</c:v>
                </c:pt>
                <c:pt idx="16">
                  <c:v>9</c:v>
                </c:pt>
                <c:pt idx="17">
                  <c:v>10</c:v>
                </c:pt>
                <c:pt idx="18">
                  <c:v>1</c:v>
                </c:pt>
                <c:pt idx="19">
                  <c:v>1</c:v>
                </c:pt>
              </c:numCache>
            </c:numRef>
          </c:val>
        </c:ser>
        <c:ser>
          <c:idx val="2"/>
          <c:order val="2"/>
          <c:tx>
            <c:strRef>
              <c:f>graph!$E$3</c:f>
              <c:strCache>
                <c:ptCount val="1"/>
                <c:pt idx="0">
                  <c:v>HD3</c:v>
                </c:pt>
              </c:strCache>
            </c:strRef>
          </c:tx>
          <c:invertIfNegative val="0"/>
          <c:cat>
            <c:strRef>
              <c:f>graph!$B$4:$B$23</c:f>
              <c:strCache>
                <c:ptCount val="20"/>
                <c:pt idx="0">
                  <c:v>CD8 + alone</c:v>
                </c:pt>
                <c:pt idx="1">
                  <c:v>CD8 + PMA/ION</c:v>
                </c:pt>
                <c:pt idx="2">
                  <c:v>CD8 + autologous DC</c:v>
                </c:pt>
                <c:pt idx="3">
                  <c:v>CD8 + auto DC+ AFP</c:v>
                </c:pt>
                <c:pt idx="4">
                  <c:v>CD8+auto DC + AdVLacZ</c:v>
                </c:pt>
                <c:pt idx="5">
                  <c:v>CD8+T2</c:v>
                </c:pt>
                <c:pt idx="6">
                  <c:v>CD8 + T2 + AFP 158</c:v>
                </c:pt>
                <c:pt idx="7">
                  <c:v>CD8 + T2 + AFP 542</c:v>
                </c:pt>
                <c:pt idx="8">
                  <c:v>CD8 + T2 + AdV hexon 711-721</c:v>
                </c:pt>
                <c:pt idx="9">
                  <c:v>CD8 + T2 + AFP 137</c:v>
                </c:pt>
                <c:pt idx="10">
                  <c:v>CD8 + T2 + AFP 325</c:v>
                </c:pt>
                <c:pt idx="12">
                  <c:v>CD4 + alone</c:v>
                </c:pt>
                <c:pt idx="13">
                  <c:v>CD4 + PMA/ION</c:v>
                </c:pt>
                <c:pt idx="14">
                  <c:v>CD4 + autologous DC</c:v>
                </c:pt>
                <c:pt idx="15">
                  <c:v>CD4 + autologous DC+AFP</c:v>
                </c:pt>
                <c:pt idx="16">
                  <c:v>CD4 + auto DC + AdVLacZ</c:v>
                </c:pt>
                <c:pt idx="17">
                  <c:v>CD4 + auto DC + AdV hexon 901-930</c:v>
                </c:pt>
                <c:pt idx="18">
                  <c:v>CD4 + auto DC + AdV hexon 856-885</c:v>
                </c:pt>
                <c:pt idx="19">
                  <c:v>CD4 + auto DC + AdV hexon 571-600</c:v>
                </c:pt>
              </c:strCache>
            </c:strRef>
          </c:cat>
          <c:val>
            <c:numRef>
              <c:f>graph!$E$4:$E$23</c:f>
              <c:numCache>
                <c:formatCode>General</c:formatCode>
                <c:ptCount val="20"/>
                <c:pt idx="0">
                  <c:v>0</c:v>
                </c:pt>
                <c:pt idx="1">
                  <c:v>1000</c:v>
                </c:pt>
                <c:pt idx="2">
                  <c:v>0</c:v>
                </c:pt>
                <c:pt idx="3">
                  <c:v>8</c:v>
                </c:pt>
                <c:pt idx="4">
                  <c:v>8</c:v>
                </c:pt>
                <c:pt idx="5">
                  <c:v>38</c:v>
                </c:pt>
                <c:pt idx="6">
                  <c:v>28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2">
                  <c:v>0</c:v>
                </c:pt>
                <c:pt idx="13">
                  <c:v>1000</c:v>
                </c:pt>
                <c:pt idx="14">
                  <c:v>5</c:v>
                </c:pt>
                <c:pt idx="15">
                  <c:v>8</c:v>
                </c:pt>
                <c:pt idx="16">
                  <c:v>35</c:v>
                </c:pt>
                <c:pt idx="17">
                  <c:v>17</c:v>
                </c:pt>
                <c:pt idx="18">
                  <c:v>6</c:v>
                </c:pt>
                <c:pt idx="19">
                  <c:v>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1950080"/>
        <c:axId val="131951616"/>
      </c:barChart>
      <c:catAx>
        <c:axId val="131950080"/>
        <c:scaling>
          <c:orientation val="minMax"/>
        </c:scaling>
        <c:delete val="0"/>
        <c:axPos val="b"/>
        <c:majorTickMark val="out"/>
        <c:minorTickMark val="none"/>
        <c:tickLblPos val="nextTo"/>
        <c:crossAx val="131951616"/>
        <c:crosses val="autoZero"/>
        <c:auto val="1"/>
        <c:lblAlgn val="ctr"/>
        <c:lblOffset val="100"/>
        <c:noMultiLvlLbl val="0"/>
      </c:catAx>
      <c:valAx>
        <c:axId val="131951616"/>
        <c:scaling>
          <c:orientation val="minMax"/>
          <c:max val="20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31950080"/>
        <c:crosses val="autoZero"/>
        <c:crossBetween val="between"/>
      </c:valAx>
      <c:spPr>
        <a:ln>
          <a:noFill/>
        </a:ln>
      </c:spPr>
    </c:plotArea>
    <c:legend>
      <c:legendPos val="r"/>
      <c:layout>
        <c:manualLayout>
          <c:xMode val="edge"/>
          <c:yMode val="edge"/>
          <c:x val="0.56242560342334602"/>
          <c:y val="0.14299760154329202"/>
          <c:w val="8.6470649992280546E-2"/>
          <c:h val="0.15391397635487591"/>
        </c:manualLayout>
      </c:layout>
      <c:overlay val="0"/>
      <c:spPr>
        <a:solidFill>
          <a:sysClr val="window" lastClr="FFFFFF"/>
        </a:solidFill>
      </c:spPr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100"/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606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67772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793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9944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86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804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30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763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421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354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829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7A8085-F50C-488F-B559-DE9E22E1FA41}" type="datetimeFigureOut">
              <a:rPr lang="en-US" smtClean="0"/>
              <a:t>3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1FFE38-17BC-4006-A4EA-DE075B9FB6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873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625339" y="62906"/>
            <a:ext cx="3157018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eaLnBrk="0" hangingPunct="0"/>
            <a:r>
              <a:rPr lang="en-US" sz="2400" dirty="0" smtClean="0">
                <a:solidFill>
                  <a:srgbClr val="000000"/>
                </a:solidFill>
              </a:rPr>
              <a:t>Supplementary Figure 1</a:t>
            </a:r>
            <a:endParaRPr lang="en-US" sz="2400" dirty="0">
              <a:solidFill>
                <a:srgbClr val="000000"/>
              </a:solidFill>
            </a:endParaRPr>
          </a:p>
        </p:txBody>
      </p:sp>
      <p:grpSp>
        <p:nvGrpSpPr>
          <p:cNvPr id="2" name="Group 14"/>
          <p:cNvGrpSpPr/>
          <p:nvPr/>
        </p:nvGrpSpPr>
        <p:grpSpPr>
          <a:xfrm>
            <a:off x="523876" y="609376"/>
            <a:ext cx="8096251" cy="3218345"/>
            <a:chOff x="523875" y="698520"/>
            <a:chExt cx="8096250" cy="5551241"/>
          </a:xfrm>
        </p:grpSpPr>
        <p:grpSp>
          <p:nvGrpSpPr>
            <p:cNvPr id="7" name="Group 10"/>
            <p:cNvGrpSpPr/>
            <p:nvPr/>
          </p:nvGrpSpPr>
          <p:grpSpPr>
            <a:xfrm>
              <a:off x="523875" y="698520"/>
              <a:ext cx="8096250" cy="5551241"/>
              <a:chOff x="523875" y="565170"/>
              <a:chExt cx="8096250" cy="5551241"/>
            </a:xfrm>
          </p:grpSpPr>
          <p:graphicFrame>
            <p:nvGraphicFramePr>
              <p:cNvPr id="3" name="Chart 2"/>
              <p:cNvGraphicFramePr/>
              <p:nvPr>
                <p:extLst>
                  <p:ext uri="{D42A27DB-BD31-4B8C-83A1-F6EECF244321}">
                    <p14:modId xmlns:p14="http://schemas.microsoft.com/office/powerpoint/2010/main" val="1533448552"/>
                  </p:ext>
                </p:extLst>
              </p:nvPr>
            </p:nvGraphicFramePr>
            <p:xfrm>
              <a:off x="523875" y="741589"/>
              <a:ext cx="8096250" cy="537482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5" name="TextBox 4"/>
              <p:cNvSpPr txBox="1"/>
              <p:nvPr/>
            </p:nvSpPr>
            <p:spPr>
              <a:xfrm>
                <a:off x="1142999" y="565170"/>
                <a:ext cx="1005583" cy="5308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solidFill>
                      <a:srgbClr val="000000"/>
                    </a:solidFill>
                  </a:rPr>
                  <a:t>&gt;1,000</a:t>
                </a: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5591173" y="574693"/>
                <a:ext cx="1043684" cy="5308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solidFill>
                      <a:srgbClr val="000000"/>
                    </a:solidFill>
                  </a:rPr>
                  <a:t>&gt;1,000</a:t>
                </a:r>
              </a:p>
            </p:txBody>
          </p:sp>
          <p:cxnSp>
            <p:nvCxnSpPr>
              <p:cNvPr id="8" name="Straight Connector 7"/>
              <p:cNvCxnSpPr/>
              <p:nvPr/>
            </p:nvCxnSpPr>
            <p:spPr bwMode="auto">
              <a:xfrm>
                <a:off x="2891125" y="3267190"/>
                <a:ext cx="1333500" cy="0"/>
              </a:xfrm>
              <a:prstGeom prst="line">
                <a:avLst/>
              </a:prstGeom>
              <a:solidFill>
                <a:schemeClr val="accent1"/>
              </a:solidFill>
              <a:ln w="12700" cap="flat" cmpd="sng" algn="ctr">
                <a:solidFill>
                  <a:srgbClr val="0070C0"/>
                </a:solidFill>
                <a:prstDash val="dash"/>
                <a:round/>
                <a:headEnd type="none" w="sm" len="sm"/>
                <a:tailEnd type="none" w="sm" len="sm"/>
              </a:ln>
              <a:effectLst/>
            </p:spPr>
          </p:cxnSp>
          <p:cxnSp>
            <p:nvCxnSpPr>
              <p:cNvPr id="9" name="Straight Connector 8"/>
              <p:cNvCxnSpPr/>
              <p:nvPr/>
            </p:nvCxnSpPr>
            <p:spPr bwMode="auto">
              <a:xfrm>
                <a:off x="3089871" y="3297159"/>
                <a:ext cx="1333500" cy="0"/>
              </a:xfrm>
              <a:prstGeom prst="line">
                <a:avLst/>
              </a:prstGeom>
              <a:solidFill>
                <a:schemeClr val="accent1"/>
              </a:solidFill>
              <a:ln w="12700" cap="flat" cmpd="sng" algn="ctr">
                <a:solidFill>
                  <a:srgbClr val="92D050"/>
                </a:solidFill>
                <a:prstDash val="dash"/>
                <a:round/>
                <a:headEnd type="none" w="sm" len="sm"/>
                <a:tailEnd type="none" w="sm" len="sm"/>
              </a:ln>
              <a:effectLst/>
            </p:spPr>
          </p:cxnSp>
        </p:grpSp>
        <p:sp>
          <p:nvSpPr>
            <p:cNvPr id="12" name="TextBox 11"/>
            <p:cNvSpPr txBox="1"/>
            <p:nvPr/>
          </p:nvSpPr>
          <p:spPr>
            <a:xfrm>
              <a:off x="2359107" y="1645774"/>
              <a:ext cx="876217" cy="5308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AdV</a:t>
              </a:r>
              <a:endParaRPr lang="en-US" sz="2400" dirty="0"/>
            </a:p>
          </p:txBody>
        </p:sp>
      </p:grpSp>
      <p:sp>
        <p:nvSpPr>
          <p:cNvPr id="16" name="TextBox 15"/>
          <p:cNvSpPr txBox="1"/>
          <p:nvPr/>
        </p:nvSpPr>
        <p:spPr>
          <a:xfrm rot="16200000">
            <a:off x="-374033" y="1569493"/>
            <a:ext cx="17347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0000"/>
                </a:solidFill>
              </a:rPr>
              <a:t>IFN</a:t>
            </a:r>
            <a:r>
              <a:rPr lang="el-GR" sz="1200" dirty="0" smtClean="0">
                <a:solidFill>
                  <a:srgbClr val="000000"/>
                </a:solidFill>
                <a:latin typeface="Calibri"/>
              </a:rPr>
              <a:t>γ</a:t>
            </a:r>
            <a:r>
              <a:rPr lang="en-US" sz="1200" dirty="0" smtClean="0">
                <a:solidFill>
                  <a:srgbClr val="000000"/>
                </a:solidFill>
              </a:rPr>
              <a:t> </a:t>
            </a:r>
            <a:r>
              <a:rPr lang="en-US" sz="1200" dirty="0">
                <a:solidFill>
                  <a:srgbClr val="000000"/>
                </a:solidFill>
              </a:rPr>
              <a:t>spots per 10e5 cells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6919489" y="1862934"/>
            <a:ext cx="854892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AdV</a:t>
            </a:r>
            <a:endParaRPr lang="en-US" sz="2400" dirty="0"/>
          </a:p>
        </p:txBody>
      </p:sp>
      <p:sp>
        <p:nvSpPr>
          <p:cNvPr id="21" name="TextBox 20"/>
          <p:cNvSpPr txBox="1"/>
          <p:nvPr/>
        </p:nvSpPr>
        <p:spPr>
          <a:xfrm>
            <a:off x="2266291" y="544376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</a:rPr>
              <a:t>CD8+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664283" y="559991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</a:rPr>
              <a:t>CD4+</a:t>
            </a:r>
          </a:p>
        </p:txBody>
      </p:sp>
    </p:spTree>
    <p:extLst>
      <p:ext uri="{BB962C8B-B14F-4D97-AF65-F5344CB8AC3E}">
        <p14:creationId xmlns:p14="http://schemas.microsoft.com/office/powerpoint/2010/main" val="18052053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9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P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s, Thomas</dc:creator>
  <cp:lastModifiedBy>Andrews, Thomas</cp:lastModifiedBy>
  <cp:revision>5</cp:revision>
  <dcterms:created xsi:type="dcterms:W3CDTF">2014-03-28T16:37:55Z</dcterms:created>
  <dcterms:modified xsi:type="dcterms:W3CDTF">2014-03-28T16:39:35Z</dcterms:modified>
</cp:coreProperties>
</file>